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1293" r:id="rId2"/>
    <p:sldId id="1292" r:id="rId3"/>
    <p:sldId id="129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188"/>
    <p:restoredTop sz="92721"/>
  </p:normalViewPr>
  <p:slideViewPr>
    <p:cSldViewPr snapToGrid="0" snapToObjects="1">
      <p:cViewPr varScale="1">
        <p:scale>
          <a:sx n="118" d="100"/>
          <a:sy n="118" d="100"/>
        </p:scale>
        <p:origin x="124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E89784-B191-D542-93C7-693D9A25E00F}" type="datetimeFigureOut">
              <a:rPr lang="en-US" smtClean="0"/>
              <a:t>1/8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BB0265-FAAE-004C-AF89-2B1F8559EF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0783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2E4807-5D11-B04E-806D-CA54B4F054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2C1E70-8159-B646-B329-3569F6713D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E4245D-9109-194C-8EE5-5F94B3C48D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4510F1-BD11-5449-91AE-08752CCB3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177697-2120-5745-B170-4C9FF3B12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20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FEB02A-B60B-DF49-999E-D47814055A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AFDBE5-1AD0-2045-819F-B1496E1D55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934FB4-E3E8-034F-97DF-99A23EB9B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7A94CC-CB0F-8945-AFA1-32CB0B3D3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959536-E7A8-184C-94A0-8896CC5AC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080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D493766-B7FF-1046-897D-B6BF299BBE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3015B9-50BD-CE4B-846E-DCA35DD21A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2632E2-E364-DB45-A899-91D11CBC5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04AE3C-3732-CB48-A18F-FAEB15C41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72D154-6C36-434D-9F92-7C3CBEC75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1318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812E04-E7B4-E342-BA8F-1A63CD200F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FBCF5A-567D-9346-AF76-F21EDCB0B0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CD7881-2FA7-0745-A8C8-DD0DF1F29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D8B383-1629-3943-9642-D1D23DA84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FD2838-3853-0345-9F70-0B7D5DFE1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939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A45074-8D6E-634E-BB73-0B2611287C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197283-5FF3-1746-B5C3-000A68720D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E8FF58-A1F2-AE4C-B56A-DBC4AB7CC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4BFABA-3BD8-2F45-896A-8A7AAAB6E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179015-CFCE-3D4B-BB54-117EF7B80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979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14B453-F43B-CA42-B39C-8C29A27B3F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D0AA8D-26C5-4746-B1BA-75A3425CBC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5F38A3-EE8B-B44D-9590-72FD95A467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BA45B9-090A-EC4D-A966-A297E3454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8D9097-8123-6B43-8873-01C063C7B7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F84A62-6FAF-BD4B-95E0-BE4FC0E1E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164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78A12-8685-A743-8DCD-C933909DE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384D14-FF08-CD4B-AF52-7D4D87E71D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2DB252-C49D-BC41-AAB2-0DA0E16F21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06450A1-CB8E-D644-95DF-C236A904EFF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0797C5-B66A-9B4A-851E-10D7C56ED4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4DB9B8C-2C69-9C4C-BCE5-ECDA2B3D3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94478DB-F54E-AE4A-ACC4-8DC1C0BBE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1BA406-9FC1-C540-8765-6FCFF6FFE5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062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55AE22-78B5-B64C-AAB5-4FB9484D3E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E956FB-F7A0-BD4E-8161-ACFA6279A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44676D-2199-C840-BAC8-8F958D5278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4BE068-D5ED-D341-9CEA-F848C3F3E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322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9C471D7-A66D-8D48-9240-A0A909377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86562F-EBBB-D04A-8EBA-7062E47A0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EF98BA-846E-4C4A-8836-785F5B9CB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294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2337DC-67D9-434E-95B2-99F3D9224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A62C73-F589-DF4C-83DD-A1B1E742BF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9EF13D-C0E5-4443-BF29-F71655782B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9F2C01-724C-704E-A9D6-D7CA870B7F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015B26-1D85-7A49-95B4-706579712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AD0614-5E6C-B840-AD32-671352479C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70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B98A7-EBBA-5241-B44A-AC577233E6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0CB9610-2E99-4C47-BB17-25D3F2BCD1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0092D2-60E7-E54F-8517-466100D1AB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B87293-397F-BE43-8D2C-D1DEC158B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344767-3175-5644-ADA2-F1BC211D50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887D74-ED1A-7C48-86DC-B4DA54183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826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773404D-66D1-1643-A419-77254AB44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4C0793-3D3D-474C-9614-55EE211B74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1AC500-6654-C34B-9C6A-12B519441B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D8AB04-469A-6840-82C0-298B34B650CA}" type="datetimeFigureOut">
              <a:rPr lang="en-US" smtClean="0"/>
              <a:t>1/8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918908-689D-6348-8480-47CD12F056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120C3C-889D-964A-9669-9F3FA3F253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3885D-1E27-BD45-827F-0612455A87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982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D2B387EB-726F-6E46-B458-1E522262F55C}"/>
              </a:ext>
            </a:extLst>
          </p:cNvPr>
          <p:cNvGrpSpPr/>
          <p:nvPr/>
        </p:nvGrpSpPr>
        <p:grpSpPr>
          <a:xfrm>
            <a:off x="1778520" y="1645310"/>
            <a:ext cx="5388313" cy="2458064"/>
            <a:chOff x="186407" y="1809316"/>
            <a:chExt cx="5388313" cy="245806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AD2FC37A-AFA3-E04D-A55D-82A86947F858}"/>
                </a:ext>
              </a:extLst>
            </p:cNvPr>
            <p:cNvGrpSpPr/>
            <p:nvPr/>
          </p:nvGrpSpPr>
          <p:grpSpPr>
            <a:xfrm>
              <a:off x="306562" y="2158747"/>
              <a:ext cx="2782020" cy="1160895"/>
              <a:chOff x="346191" y="4066587"/>
              <a:chExt cx="2782020" cy="1160895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AF44EC71-78E3-5449-AB28-CB8E729CB9F2}"/>
                  </a:ext>
                </a:extLst>
              </p:cNvPr>
              <p:cNvSpPr txBox="1"/>
              <p:nvPr/>
            </p:nvSpPr>
            <p:spPr>
              <a:xfrm rot="16200000">
                <a:off x="94359" y="4614252"/>
                <a:ext cx="811441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CA1F9FD-BB9C-8B4C-AE12-666606135E9D}"/>
                  </a:ext>
                </a:extLst>
              </p:cNvPr>
              <p:cNvSpPr txBox="1"/>
              <p:nvPr/>
            </p:nvSpPr>
            <p:spPr>
              <a:xfrm rot="16200000">
                <a:off x="356205" y="4493146"/>
                <a:ext cx="1160895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Heat Shock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2A251FC-8B77-2242-A5A3-E112ED5D1A3C}"/>
                  </a:ext>
                </a:extLst>
              </p:cNvPr>
              <p:cNvSpPr txBox="1"/>
              <p:nvPr/>
            </p:nvSpPr>
            <p:spPr>
              <a:xfrm rot="16200000">
                <a:off x="1094739" y="4614252"/>
                <a:ext cx="811441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C5576EC-B0BC-FA4E-9212-9620491B7CDC}"/>
                  </a:ext>
                </a:extLst>
              </p:cNvPr>
              <p:cNvSpPr txBox="1"/>
              <p:nvPr/>
            </p:nvSpPr>
            <p:spPr>
              <a:xfrm rot="16200000">
                <a:off x="2193624" y="4705529"/>
                <a:ext cx="655692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Water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07FB04D8-DBBC-A141-AD5E-C908B7105993}"/>
                  </a:ext>
                </a:extLst>
              </p:cNvPr>
              <p:cNvSpPr txBox="1"/>
              <p:nvPr/>
            </p:nvSpPr>
            <p:spPr>
              <a:xfrm rot="16200000">
                <a:off x="2642341" y="4681522"/>
                <a:ext cx="663964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gDNA</a:t>
                </a:r>
              </a:p>
            </p:txBody>
          </p:sp>
        </p:grp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C198487-3714-454D-82F4-B55FD925CE2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49343" r="25646"/>
            <a:stretch/>
          </p:blipFill>
          <p:spPr>
            <a:xfrm>
              <a:off x="186407" y="3231056"/>
              <a:ext cx="3131765" cy="1036324"/>
            </a:xfrm>
            <a:prstGeom prst="rect">
              <a:avLst/>
            </a:prstGeom>
            <a:ln>
              <a:noFill/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7250543-0566-434B-A411-CFA570286EAA}"/>
                </a:ext>
              </a:extLst>
            </p:cNvPr>
            <p:cNvSpPr txBox="1"/>
            <p:nvPr/>
          </p:nvSpPr>
          <p:spPr>
            <a:xfrm>
              <a:off x="3288517" y="3346186"/>
              <a:ext cx="228620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HI_146360 (</a:t>
              </a:r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hERM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-BP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8B896BB-7D92-6B4E-843E-78F8D9DFF27A}"/>
                </a:ext>
              </a:extLst>
            </p:cNvPr>
            <p:cNvSpPr txBox="1"/>
            <p:nvPr/>
          </p:nvSpPr>
          <p:spPr>
            <a:xfrm>
              <a:off x="3288517" y="3813314"/>
              <a:ext cx="19848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HI_199600 (Control)</a:t>
              </a:r>
            </a:p>
          </p:txBody>
        </p:sp>
        <p:sp>
          <p:nvSpPr>
            <p:cNvPr id="9" name="Left Bracket 8">
              <a:extLst>
                <a:ext uri="{FF2B5EF4-FFF2-40B4-BE49-F238E27FC236}">
                  <a16:creationId xmlns:a16="http://schemas.microsoft.com/office/drawing/2014/main" id="{10FEDC9F-8423-D647-A545-E2236DEF637A}"/>
                </a:ext>
              </a:extLst>
            </p:cNvPr>
            <p:cNvSpPr/>
            <p:nvPr/>
          </p:nvSpPr>
          <p:spPr>
            <a:xfrm rot="5400000">
              <a:off x="661161" y="1765057"/>
              <a:ext cx="58786" cy="782053"/>
            </a:xfrm>
            <a:prstGeom prst="lef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0" name="Left Bracket 9">
              <a:extLst>
                <a:ext uri="{FF2B5EF4-FFF2-40B4-BE49-F238E27FC236}">
                  <a16:creationId xmlns:a16="http://schemas.microsoft.com/office/drawing/2014/main" id="{111E9A44-186E-F447-99CF-DF9766A3E312}"/>
                </a:ext>
              </a:extLst>
            </p:cNvPr>
            <p:cNvSpPr/>
            <p:nvPr/>
          </p:nvSpPr>
          <p:spPr>
            <a:xfrm rot="5400000">
              <a:off x="1686492" y="1765058"/>
              <a:ext cx="58786" cy="782053"/>
            </a:xfrm>
            <a:prstGeom prst="lef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1" name="Left Bracket 10">
              <a:extLst>
                <a:ext uri="{FF2B5EF4-FFF2-40B4-BE49-F238E27FC236}">
                  <a16:creationId xmlns:a16="http://schemas.microsoft.com/office/drawing/2014/main" id="{EA5FD0E5-0E58-644A-AC30-1E39D3AE9255}"/>
                </a:ext>
              </a:extLst>
            </p:cNvPr>
            <p:cNvSpPr/>
            <p:nvPr/>
          </p:nvSpPr>
          <p:spPr>
            <a:xfrm rot="5400000">
              <a:off x="2658589" y="1773079"/>
              <a:ext cx="58786" cy="782053"/>
            </a:xfrm>
            <a:prstGeom prst="leftBracket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A47B9F1-3C1F-804D-989C-CA3978511A15}"/>
                </a:ext>
              </a:extLst>
            </p:cNvPr>
            <p:cNvSpPr txBox="1"/>
            <p:nvPr/>
          </p:nvSpPr>
          <p:spPr>
            <a:xfrm>
              <a:off x="420346" y="1809316"/>
              <a:ext cx="6527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cs typeface="Arial" panose="020B0604020202020204" pitchFamily="34" charset="0"/>
                </a:rPr>
                <a:t>┼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RT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5DF035A-AAFF-EC4E-83F9-A3BFC4CC0F6E}"/>
                </a:ext>
              </a:extLst>
            </p:cNvPr>
            <p:cNvSpPr txBox="1"/>
            <p:nvPr/>
          </p:nvSpPr>
          <p:spPr>
            <a:xfrm>
              <a:off x="1446502" y="1825082"/>
              <a:ext cx="5677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⎯</a:t>
              </a:r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RT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2F30355-676B-8549-9581-8F81E97218D4}"/>
                </a:ext>
              </a:extLst>
            </p:cNvPr>
            <p:cNvSpPr txBox="1"/>
            <p:nvPr/>
          </p:nvSpPr>
          <p:spPr>
            <a:xfrm>
              <a:off x="2265670" y="1813341"/>
              <a:ext cx="9204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s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0D141E9E-8E79-8A4B-8F46-DCBED3DA8209}"/>
              </a:ext>
            </a:extLst>
          </p:cNvPr>
          <p:cNvSpPr txBox="1"/>
          <p:nvPr/>
        </p:nvSpPr>
        <p:spPr>
          <a:xfrm rot="16200000">
            <a:off x="2923272" y="2427475"/>
            <a:ext cx="1160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Heat Shock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A10827C-4EC2-2341-AD1C-5D5747B67786}"/>
              </a:ext>
            </a:extLst>
          </p:cNvPr>
          <p:cNvSpPr txBox="1"/>
          <p:nvPr/>
        </p:nvSpPr>
        <p:spPr>
          <a:xfrm>
            <a:off x="144269" y="222844"/>
            <a:ext cx="36888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1519237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0ACC49F-CE13-884C-B861-AAA730892ED3}"/>
              </a:ext>
            </a:extLst>
          </p:cNvPr>
          <p:cNvSpPr txBox="1"/>
          <p:nvPr/>
        </p:nvSpPr>
        <p:spPr>
          <a:xfrm>
            <a:off x="117230" y="-8527"/>
            <a:ext cx="36888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8647549-655D-6749-88DA-1910C8CB0271}"/>
              </a:ext>
            </a:extLst>
          </p:cNvPr>
          <p:cNvSpPr txBox="1"/>
          <p:nvPr/>
        </p:nvSpPr>
        <p:spPr>
          <a:xfrm>
            <a:off x="2960189" y="441622"/>
            <a:ext cx="49244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62D445B-9CFC-FE4E-ADA7-E8F84852E0DE}"/>
              </a:ext>
            </a:extLst>
          </p:cNvPr>
          <p:cNvSpPr txBox="1"/>
          <p:nvPr/>
        </p:nvSpPr>
        <p:spPr>
          <a:xfrm>
            <a:off x="2960189" y="3582375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59" name="Picture 58">
            <a:extLst>
              <a:ext uri="{FF2B5EF4-FFF2-40B4-BE49-F238E27FC236}">
                <a16:creationId xmlns:a16="http://schemas.microsoft.com/office/drawing/2014/main" id="{82242D5A-9489-5449-AF07-8C3A9F8D3A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38626" y="4077043"/>
            <a:ext cx="8064500" cy="2806700"/>
          </a:xfrm>
          <a:prstGeom prst="rect">
            <a:avLst/>
          </a:prstGeom>
        </p:spPr>
      </p:pic>
      <p:grpSp>
        <p:nvGrpSpPr>
          <p:cNvPr id="61" name="Group 60">
            <a:extLst>
              <a:ext uri="{FF2B5EF4-FFF2-40B4-BE49-F238E27FC236}">
                <a16:creationId xmlns:a16="http://schemas.microsoft.com/office/drawing/2014/main" id="{6A728F76-80B8-604D-8C26-C5FDDC393658}"/>
              </a:ext>
            </a:extLst>
          </p:cNvPr>
          <p:cNvGrpSpPr/>
          <p:nvPr/>
        </p:nvGrpSpPr>
        <p:grpSpPr>
          <a:xfrm>
            <a:off x="4857741" y="3665683"/>
            <a:ext cx="4446802" cy="665766"/>
            <a:chOff x="4812771" y="3740633"/>
            <a:chExt cx="4446802" cy="665766"/>
          </a:xfrm>
        </p:grpSpPr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55F9E12-DE63-2743-8B10-1BF1122459B3}"/>
                </a:ext>
              </a:extLst>
            </p:cNvPr>
            <p:cNvSpPr txBox="1"/>
            <p:nvPr/>
          </p:nvSpPr>
          <p:spPr>
            <a:xfrm>
              <a:off x="8847115" y="3944734"/>
              <a:ext cx="1733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latin typeface="Arial"/>
                  <a:cs typeface="Arial"/>
                </a:rPr>
                <a:t>*</a:t>
              </a:r>
            </a:p>
          </p:txBody>
        </p: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E0D2CF55-760C-2342-BFFE-6BDA486B5FBA}"/>
                </a:ext>
              </a:extLst>
            </p:cNvPr>
            <p:cNvGrpSpPr/>
            <p:nvPr/>
          </p:nvGrpSpPr>
          <p:grpSpPr>
            <a:xfrm>
              <a:off x="4812771" y="3740633"/>
              <a:ext cx="4446802" cy="507227"/>
              <a:chOff x="4800367" y="396060"/>
              <a:chExt cx="4446802" cy="507227"/>
            </a:xfrm>
          </p:grpSpPr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id="{053F2B39-E52A-4040-8FEA-F2CEE4663D84}"/>
                  </a:ext>
                </a:extLst>
              </p:cNvPr>
              <p:cNvCxnSpPr/>
              <p:nvPr/>
            </p:nvCxnSpPr>
            <p:spPr>
              <a:xfrm>
                <a:off x="8740983" y="903287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id="{3A08BF39-3D25-2445-B994-F2DB19912104}"/>
                  </a:ext>
                </a:extLst>
              </p:cNvPr>
              <p:cNvCxnSpPr/>
              <p:nvPr/>
            </p:nvCxnSpPr>
            <p:spPr>
              <a:xfrm>
                <a:off x="7734071" y="848630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83C7699A-5D5E-734F-AA8A-0F9E8C657912}"/>
                  </a:ext>
                </a:extLst>
              </p:cNvPr>
              <p:cNvCxnSpPr/>
              <p:nvPr/>
            </p:nvCxnSpPr>
            <p:spPr>
              <a:xfrm>
                <a:off x="6694483" y="837290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CA617F3B-C1F0-E441-854D-46801192984A}"/>
                  </a:ext>
                </a:extLst>
              </p:cNvPr>
              <p:cNvCxnSpPr/>
              <p:nvPr/>
            </p:nvCxnSpPr>
            <p:spPr>
              <a:xfrm>
                <a:off x="5741981" y="777421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>
                <a:extLst>
                  <a:ext uri="{FF2B5EF4-FFF2-40B4-BE49-F238E27FC236}">
                    <a16:creationId xmlns:a16="http://schemas.microsoft.com/office/drawing/2014/main" id="{C89EDF6A-5C2A-A041-BBD3-855C0783A1D3}"/>
                  </a:ext>
                </a:extLst>
              </p:cNvPr>
              <p:cNvCxnSpPr/>
              <p:nvPr/>
            </p:nvCxnSpPr>
            <p:spPr>
              <a:xfrm>
                <a:off x="4800367" y="744763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18A7FF2C-5DD9-3A4D-BB3D-04E6D09BB684}"/>
                  </a:ext>
                </a:extLst>
              </p:cNvPr>
              <p:cNvSpPr txBox="1"/>
              <p:nvPr/>
            </p:nvSpPr>
            <p:spPr>
              <a:xfrm flipH="1">
                <a:off x="6792909" y="497601"/>
                <a:ext cx="6457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Arial"/>
                    <a:cs typeface="Arial"/>
                  </a:rPr>
                  <a:t>ns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01362A3-E89C-9A4B-BDE5-08FEC36EED94}"/>
                  </a:ext>
                </a:extLst>
              </p:cNvPr>
              <p:cNvSpPr txBox="1"/>
              <p:nvPr/>
            </p:nvSpPr>
            <p:spPr>
              <a:xfrm flipH="1">
                <a:off x="5802308" y="468709"/>
                <a:ext cx="6457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Arial"/>
                    <a:cs typeface="Arial"/>
                  </a:rPr>
                  <a:t>ns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54F66756-0055-594A-8FC4-E6F1D77FB20C}"/>
                  </a:ext>
                </a:extLst>
              </p:cNvPr>
              <p:cNvSpPr txBox="1"/>
              <p:nvPr/>
            </p:nvSpPr>
            <p:spPr>
              <a:xfrm flipH="1">
                <a:off x="4812771" y="396060"/>
                <a:ext cx="6457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Arial"/>
                    <a:cs typeface="Arial"/>
                  </a:rPr>
                  <a:t>ns</a:t>
                </a:r>
              </a:p>
            </p:txBody>
          </p:sp>
        </p:grp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06082DA-5156-E74B-9B2F-39AB25209C18}"/>
                </a:ext>
              </a:extLst>
            </p:cNvPr>
            <p:cNvSpPr txBox="1"/>
            <p:nvPr/>
          </p:nvSpPr>
          <p:spPr>
            <a:xfrm flipH="1">
              <a:off x="7806797" y="3863944"/>
              <a:ext cx="6457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/>
                  <a:cs typeface="Arial"/>
                </a:rPr>
                <a:t>ns</a:t>
              </a:r>
            </a:p>
          </p:txBody>
        </p:sp>
      </p:grpSp>
      <p:pic>
        <p:nvPicPr>
          <p:cNvPr id="74" name="Picture 73">
            <a:extLst>
              <a:ext uri="{FF2B5EF4-FFF2-40B4-BE49-F238E27FC236}">
                <a16:creationId xmlns:a16="http://schemas.microsoft.com/office/drawing/2014/main" id="{E06654F1-D11F-0045-B27F-E334EC54B6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2632" y="863173"/>
            <a:ext cx="7835900" cy="2552700"/>
          </a:xfrm>
          <a:prstGeom prst="rect">
            <a:avLst/>
          </a:prstGeom>
        </p:spPr>
      </p:pic>
      <p:grpSp>
        <p:nvGrpSpPr>
          <p:cNvPr id="76" name="Group 75">
            <a:extLst>
              <a:ext uri="{FF2B5EF4-FFF2-40B4-BE49-F238E27FC236}">
                <a16:creationId xmlns:a16="http://schemas.microsoft.com/office/drawing/2014/main" id="{05EE9D70-9AA6-0540-9B3E-93110361EC09}"/>
              </a:ext>
            </a:extLst>
          </p:cNvPr>
          <p:cNvGrpSpPr/>
          <p:nvPr/>
        </p:nvGrpSpPr>
        <p:grpSpPr>
          <a:xfrm>
            <a:off x="4800367" y="396060"/>
            <a:ext cx="4316170" cy="696850"/>
            <a:chOff x="4800367" y="396060"/>
            <a:chExt cx="4316170" cy="696850"/>
          </a:xfrm>
        </p:grpSpPr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303C140-A675-1346-AE61-544016BEE284}"/>
                </a:ext>
              </a:extLst>
            </p:cNvPr>
            <p:cNvSpPr txBox="1"/>
            <p:nvPr/>
          </p:nvSpPr>
          <p:spPr>
            <a:xfrm>
              <a:off x="7764812" y="631245"/>
              <a:ext cx="1733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D786C68-6DD9-A24C-8592-ADDD9BD97DF4}"/>
                </a:ext>
              </a:extLst>
            </p:cNvPr>
            <p:cNvSpPr txBox="1"/>
            <p:nvPr/>
          </p:nvSpPr>
          <p:spPr>
            <a:xfrm>
              <a:off x="8709228" y="631244"/>
              <a:ext cx="1733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latin typeface="Arial"/>
                  <a:cs typeface="Arial"/>
                </a:rPr>
                <a:t>*</a:t>
              </a:r>
            </a:p>
          </p:txBody>
        </p: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FF8C94DA-3887-2244-B6AF-F2CFA8F008E8}"/>
                </a:ext>
              </a:extLst>
            </p:cNvPr>
            <p:cNvGrpSpPr/>
            <p:nvPr/>
          </p:nvGrpSpPr>
          <p:grpSpPr>
            <a:xfrm>
              <a:off x="4800367" y="396060"/>
              <a:ext cx="4316170" cy="507227"/>
              <a:chOff x="4800367" y="396060"/>
              <a:chExt cx="4316170" cy="507227"/>
            </a:xfrm>
          </p:grpSpPr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FCA66E6D-ADD7-034C-8F13-EDA82B3F9751}"/>
                  </a:ext>
                </a:extLst>
              </p:cNvPr>
              <p:cNvCxnSpPr/>
              <p:nvPr/>
            </p:nvCxnSpPr>
            <p:spPr>
              <a:xfrm>
                <a:off x="8610351" y="903287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6CFFB14C-9A34-6D40-AFA8-BE827FEFA348}"/>
                  </a:ext>
                </a:extLst>
              </p:cNvPr>
              <p:cNvCxnSpPr/>
              <p:nvPr/>
            </p:nvCxnSpPr>
            <p:spPr>
              <a:xfrm>
                <a:off x="7636097" y="897617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>
                <a:extLst>
                  <a:ext uri="{FF2B5EF4-FFF2-40B4-BE49-F238E27FC236}">
                    <a16:creationId xmlns:a16="http://schemas.microsoft.com/office/drawing/2014/main" id="{BDF48FCD-69E5-A742-B67A-678ADD1358AF}"/>
                  </a:ext>
                </a:extLst>
              </p:cNvPr>
              <p:cNvCxnSpPr/>
              <p:nvPr/>
            </p:nvCxnSpPr>
            <p:spPr>
              <a:xfrm>
                <a:off x="6694483" y="837290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id="{76E409D3-1045-1740-BE4D-708CC1407144}"/>
                  </a:ext>
                </a:extLst>
              </p:cNvPr>
              <p:cNvCxnSpPr/>
              <p:nvPr/>
            </p:nvCxnSpPr>
            <p:spPr>
              <a:xfrm>
                <a:off x="5741981" y="777421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Straight Connector 83">
                <a:extLst>
                  <a:ext uri="{FF2B5EF4-FFF2-40B4-BE49-F238E27FC236}">
                    <a16:creationId xmlns:a16="http://schemas.microsoft.com/office/drawing/2014/main" id="{29029646-67F6-574F-8660-052E72A9463E}"/>
                  </a:ext>
                </a:extLst>
              </p:cNvPr>
              <p:cNvCxnSpPr/>
              <p:nvPr/>
            </p:nvCxnSpPr>
            <p:spPr>
              <a:xfrm>
                <a:off x="4800367" y="744763"/>
                <a:ext cx="506186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597A56CF-28D5-784C-9B30-6C57CFF90A03}"/>
                  </a:ext>
                </a:extLst>
              </p:cNvPr>
              <p:cNvSpPr txBox="1"/>
              <p:nvPr/>
            </p:nvSpPr>
            <p:spPr>
              <a:xfrm flipH="1">
                <a:off x="6743922" y="497601"/>
                <a:ext cx="6457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Arial"/>
                    <a:cs typeface="Arial"/>
                  </a:rPr>
                  <a:t>ns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DE9527FA-8232-0040-AFEB-3B31CFF78BA7}"/>
                  </a:ext>
                </a:extLst>
              </p:cNvPr>
              <p:cNvSpPr txBox="1"/>
              <p:nvPr/>
            </p:nvSpPr>
            <p:spPr>
              <a:xfrm flipH="1">
                <a:off x="5802308" y="468709"/>
                <a:ext cx="6457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Arial"/>
                    <a:cs typeface="Arial"/>
                  </a:rPr>
                  <a:t>ns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95B0DCD6-A583-5B4C-98D1-78ACE475A94C}"/>
                  </a:ext>
                </a:extLst>
              </p:cNvPr>
              <p:cNvSpPr txBox="1"/>
              <p:nvPr/>
            </p:nvSpPr>
            <p:spPr>
              <a:xfrm flipH="1">
                <a:off x="4812771" y="396060"/>
                <a:ext cx="64573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>
                    <a:latin typeface="Arial"/>
                    <a:cs typeface="Arial"/>
                  </a:rPr>
                  <a:t>n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4811360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1E1869-B74A-684E-893E-8D6ACE9E9953}"/>
              </a:ext>
            </a:extLst>
          </p:cNvPr>
          <p:cNvSpPr txBox="1"/>
          <p:nvPr/>
        </p:nvSpPr>
        <p:spPr>
          <a:xfrm>
            <a:off x="2630988" y="862655"/>
            <a:ext cx="78547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ight Field                                  FDA                                   Hoechst 42                                    Merged 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D53CFB0-C08C-CE44-A9D6-B0848C8CEEAC}"/>
              </a:ext>
            </a:extLst>
          </p:cNvPr>
          <p:cNvSpPr txBox="1"/>
          <p:nvPr/>
        </p:nvSpPr>
        <p:spPr>
          <a:xfrm rot="16200000">
            <a:off x="481530" y="3590445"/>
            <a:ext cx="23829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latin typeface="Arial"/>
                <a:cs typeface="Arial"/>
              </a:rPr>
              <a:t>E. histolytica </a:t>
            </a:r>
            <a:r>
              <a:rPr lang="en-US" sz="1400" b="1" dirty="0">
                <a:latin typeface="Arial"/>
                <a:cs typeface="Arial"/>
              </a:rPr>
              <a:t>Heat-shock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03BDF67-3D96-2444-A83D-AF98ABD38A9B}"/>
              </a:ext>
            </a:extLst>
          </p:cNvPr>
          <p:cNvSpPr txBox="1"/>
          <p:nvPr/>
        </p:nvSpPr>
        <p:spPr>
          <a:xfrm>
            <a:off x="117230" y="-8527"/>
            <a:ext cx="36888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3CA3362D-E13D-0E48-AC16-C0C48114C0F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60860" y="1170480"/>
            <a:ext cx="88900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3016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58</TotalTime>
  <Words>60</Words>
  <Application>Microsoft Macintosh PowerPoint</Application>
  <PresentationFormat>Widescreen</PresentationFormat>
  <Paragraphs>2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pak Manna</dc:creator>
  <cp:lastModifiedBy>Upinder Singh</cp:lastModifiedBy>
  <cp:revision>129</cp:revision>
  <dcterms:created xsi:type="dcterms:W3CDTF">2019-11-22T20:47:20Z</dcterms:created>
  <dcterms:modified xsi:type="dcterms:W3CDTF">2020-01-09T02:02:16Z</dcterms:modified>
</cp:coreProperties>
</file>